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5940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136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5334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510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9670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3811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1777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3136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7856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1365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3266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0A26C-90AB-43BB-B12C-A2AEB35E3254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645AB-06EC-4E0F-A762-987F470269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5241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31454" y="253353"/>
            <a:ext cx="8762765" cy="6293617"/>
            <a:chOff x="231454" y="253353"/>
            <a:chExt cx="8762765" cy="6293617"/>
          </a:xfrm>
        </p:grpSpPr>
        <p:sp>
          <p:nvSpPr>
            <p:cNvPr id="5" name="Textfeld 4"/>
            <p:cNvSpPr txBox="1"/>
            <p:nvPr/>
          </p:nvSpPr>
          <p:spPr>
            <a:xfrm>
              <a:off x="1115616" y="919753"/>
              <a:ext cx="2062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eek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ob/ob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emales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1043608" y="3861048"/>
              <a:ext cx="22365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onth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ob/ob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ales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Gerade Verbindung 17"/>
            <p:cNvCxnSpPr/>
            <p:nvPr/>
          </p:nvCxnSpPr>
          <p:spPr>
            <a:xfrm>
              <a:off x="1403648" y="1473751"/>
              <a:ext cx="12241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feld 7"/>
            <p:cNvSpPr txBox="1"/>
            <p:nvPr/>
          </p:nvSpPr>
          <p:spPr>
            <a:xfrm>
              <a:off x="1835696" y="126876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" name="Textfeld 56"/>
            <p:cNvSpPr txBox="1"/>
            <p:nvPr/>
          </p:nvSpPr>
          <p:spPr>
            <a:xfrm>
              <a:off x="231454" y="332656"/>
              <a:ext cx="371072" cy="472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A</a:t>
              </a:r>
              <a:endParaRPr lang="de-DE" sz="1200" dirty="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10" name="Picture 6" descr="E:\representatives\female control crtl2 3-3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3886598" y="74660"/>
              <a:ext cx="1542990" cy="19003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9" descr="E:\representatives\obob3 18-1 female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6889" y="1837527"/>
              <a:ext cx="2376264" cy="15429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1" descr="E:\representatives\RGS4 crtl3 16-2 female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7905" y="3429000"/>
              <a:ext cx="1900378" cy="15429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3" descr="E:\representatives\RGS4 obob3 16-3 female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7904" y="5003979"/>
              <a:ext cx="1900379" cy="15429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Rechteck 13"/>
            <p:cNvSpPr/>
            <p:nvPr/>
          </p:nvSpPr>
          <p:spPr>
            <a:xfrm>
              <a:off x="5608283" y="1796344"/>
              <a:ext cx="547893" cy="18486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Rechteck 14"/>
            <p:cNvSpPr/>
            <p:nvPr/>
          </p:nvSpPr>
          <p:spPr>
            <a:xfrm>
              <a:off x="3160012" y="1531838"/>
              <a:ext cx="547893" cy="18486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6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5369217" y="1700808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5383848" y="3284984"/>
              <a:ext cx="201393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5369217" y="4869160"/>
              <a:ext cx="201775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5383848" y="6453336"/>
              <a:ext cx="18714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feld 56"/>
            <p:cNvSpPr txBox="1"/>
            <p:nvPr/>
          </p:nvSpPr>
          <p:spPr>
            <a:xfrm>
              <a:off x="3131841" y="332656"/>
              <a:ext cx="371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B</a:t>
              </a:r>
              <a:endParaRPr 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5016446" y="1662444"/>
              <a:ext cx="14964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reptavidin</a:t>
              </a:r>
              <a:r>
                <a:rPr lang="de-DE" sz="1200" dirty="0">
                  <a:solidFill>
                    <a:schemeClr val="tx2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DE" sz="1200" dirty="0">
                  <a:solidFill>
                    <a:schemeClr val="tx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2" name="Textfeld 21"/>
            <p:cNvSpPr txBox="1"/>
            <p:nvPr/>
          </p:nvSpPr>
          <p:spPr>
            <a:xfrm rot="16200000">
              <a:off x="5246413" y="4888860"/>
              <a:ext cx="1036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GS4</a:t>
              </a:r>
              <a:r>
                <a:rPr lang="de-DE" sz="1200" dirty="0">
                  <a:solidFill>
                    <a:schemeClr val="tx2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DE" sz="1200" dirty="0">
                  <a:solidFill>
                    <a:schemeClr val="tx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de-DE" sz="1000" dirty="0">
                <a:solidFill>
                  <a:schemeClr val="tx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 rot="16200000">
              <a:off x="3242982" y="4063058"/>
              <a:ext cx="6810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547AE995-E6F1-400D-85E5-1DCDB2EC13F6}"/>
                </a:ext>
              </a:extLst>
            </p:cNvPr>
            <p:cNvSpPr txBox="1"/>
            <p:nvPr/>
          </p:nvSpPr>
          <p:spPr>
            <a:xfrm rot="16200000">
              <a:off x="3249229" y="5620722"/>
              <a:ext cx="668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ob/o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 rot="16200000">
              <a:off x="3239928" y="894706"/>
              <a:ext cx="6810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547AE995-E6F1-400D-85E5-1DCDB2EC13F6}"/>
                </a:ext>
              </a:extLst>
            </p:cNvPr>
            <p:cNvSpPr txBox="1"/>
            <p:nvPr/>
          </p:nvSpPr>
          <p:spPr>
            <a:xfrm rot="16200000">
              <a:off x="3246175" y="2452370"/>
              <a:ext cx="668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ob/o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Gerade Verbindung 60"/>
            <p:cNvCxnSpPr/>
            <p:nvPr/>
          </p:nvCxnSpPr>
          <p:spPr>
            <a:xfrm>
              <a:off x="1403648" y="4437112"/>
              <a:ext cx="12241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/>
            <p:cNvSpPr txBox="1"/>
            <p:nvPr/>
          </p:nvSpPr>
          <p:spPr>
            <a:xfrm>
              <a:off x="1835696" y="4232121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pic>
          <p:nvPicPr>
            <p:cNvPr id="29" name="Picture 2" descr="U:\a\Doktorarbeit\Dokumente\PNAS Paper\ob male weight.em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8510" y="4306311"/>
              <a:ext cx="2867674" cy="22406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" name="Picture 3" descr="U:\a\Doktorarbeit\Dokumente\PNAS Paper\ob female weight.em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7786" y="1268760"/>
              <a:ext cx="2808398" cy="22406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" name="Picture 6" descr="C:\Users\Werdermar\Desktop\representatives NesStar Obm\JPEGS\ob2 11-3-3\C1-Composite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8224" y="1849790"/>
              <a:ext cx="2160240" cy="1521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2" name="Picture 7" descr="C:\Users\Werdermar\Desktop\representatives NesStar Obm\JPEGS\ob2 11-3-3\C2-Composite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8224" y="3434315"/>
              <a:ext cx="2160240" cy="1521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8" descr="C:\Users\Werdermar\Desktop\representatives NesStar Obm\JPEGS\ob2 11-3-3\C3-Composite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91273" y="5024983"/>
              <a:ext cx="2160240" cy="1521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9" descr="C:\Users\Werdermar\Desktop\representatives NesStar Obm\JPEGS\ob2 11-3-3\ob2 11-3-3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91274" y="253353"/>
              <a:ext cx="2160240" cy="15264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5" name="Textfeld 56"/>
            <p:cNvSpPr txBox="1"/>
            <p:nvPr/>
          </p:nvSpPr>
          <p:spPr>
            <a:xfrm>
              <a:off x="6217152" y="332656"/>
              <a:ext cx="371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C</a:t>
              </a:r>
              <a:endParaRPr lang="de-DE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547AE995-E6F1-400D-85E5-1DCDB2EC13F6}"/>
                </a:ext>
              </a:extLst>
            </p:cNvPr>
            <p:cNvSpPr txBox="1"/>
            <p:nvPr/>
          </p:nvSpPr>
          <p:spPr>
            <a:xfrm rot="16200000">
              <a:off x="8521459" y="2524191"/>
              <a:ext cx="668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tAR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547AE995-E6F1-400D-85E5-1DCDB2EC13F6}"/>
                </a:ext>
              </a:extLst>
            </p:cNvPr>
            <p:cNvSpPr txBox="1"/>
            <p:nvPr/>
          </p:nvSpPr>
          <p:spPr>
            <a:xfrm rot="16200000">
              <a:off x="8521459" y="4056810"/>
              <a:ext cx="668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estin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547AE995-E6F1-400D-85E5-1DCDB2EC13F6}"/>
                </a:ext>
              </a:extLst>
            </p:cNvPr>
            <p:cNvSpPr txBox="1"/>
            <p:nvPr/>
          </p:nvSpPr>
          <p:spPr>
            <a:xfrm rot="16200000">
              <a:off x="8521459" y="5620535"/>
              <a:ext cx="668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8460432" y="1813195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8460432" y="3380518"/>
              <a:ext cx="21602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r Verbinder 114">
              <a:extLst>
                <a:ext uri="{FF2B5EF4-FFF2-40B4-BE49-F238E27FC236}">
                  <a16:creationId xmlns:a16="http://schemas.microsoft.com/office/drawing/2014/main" id="{B97C7B25-54BD-429E-B377-7E455BAED69E}"/>
                </a:ext>
              </a:extLst>
            </p:cNvPr>
            <p:cNvCxnSpPr>
              <a:cxnSpLocks/>
            </p:cNvCxnSpPr>
            <p:nvPr/>
          </p:nvCxnSpPr>
          <p:spPr>
            <a:xfrm>
              <a:off x="8475583" y="6453336"/>
              <a:ext cx="21602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mit Pfeil 41"/>
            <p:cNvCxnSpPr>
              <a:cxnSpLocks noChangeAspect="1"/>
            </p:cNvCxnSpPr>
            <p:nvPr/>
          </p:nvCxnSpPr>
          <p:spPr>
            <a:xfrm flipH="1">
              <a:off x="7956376" y="492361"/>
              <a:ext cx="228490" cy="120608"/>
            </a:xfrm>
            <a:prstGeom prst="straightConnector1">
              <a:avLst/>
            </a:prstGeom>
            <a:ln w="12700">
              <a:solidFill>
                <a:schemeClr val="bg1">
                  <a:lumMod val="9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mit Pfeil 42"/>
            <p:cNvCxnSpPr>
              <a:cxnSpLocks noChangeAspect="1"/>
            </p:cNvCxnSpPr>
            <p:nvPr/>
          </p:nvCxnSpPr>
          <p:spPr>
            <a:xfrm flipH="1">
              <a:off x="7727886" y="2131139"/>
              <a:ext cx="228490" cy="120608"/>
            </a:xfrm>
            <a:prstGeom prst="straightConnector1">
              <a:avLst/>
            </a:prstGeom>
            <a:ln w="12700">
              <a:solidFill>
                <a:schemeClr val="bg1">
                  <a:lumMod val="9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mit Pfeil 43"/>
            <p:cNvCxnSpPr>
              <a:cxnSpLocks noChangeAspect="1"/>
            </p:cNvCxnSpPr>
            <p:nvPr/>
          </p:nvCxnSpPr>
          <p:spPr>
            <a:xfrm flipH="1">
              <a:off x="7956376" y="3661207"/>
              <a:ext cx="228490" cy="120608"/>
            </a:xfrm>
            <a:prstGeom prst="straightConnector1">
              <a:avLst/>
            </a:prstGeom>
            <a:ln w="12700">
              <a:solidFill>
                <a:schemeClr val="bg1">
                  <a:lumMod val="9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 Verbindung mit Pfeil 44"/>
            <p:cNvCxnSpPr>
              <a:cxnSpLocks noChangeAspect="1"/>
            </p:cNvCxnSpPr>
            <p:nvPr/>
          </p:nvCxnSpPr>
          <p:spPr>
            <a:xfrm flipH="1">
              <a:off x="7911122" y="5304165"/>
              <a:ext cx="228490" cy="120608"/>
            </a:xfrm>
            <a:prstGeom prst="straightConnector1">
              <a:avLst/>
            </a:prstGeom>
            <a:ln w="12700">
              <a:solidFill>
                <a:schemeClr val="bg1">
                  <a:lumMod val="9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r Verbinder 114">
              <a:extLst>
                <a:ext uri="{FF2B5EF4-FFF2-40B4-BE49-F238E27FC236}">
                  <a16:creationId xmlns:a16="http://schemas.microsoft.com/office/drawing/2014/main" id="{96A66667-8A3B-4946-876B-E7D26DC1AE90}"/>
                </a:ext>
              </a:extLst>
            </p:cNvPr>
            <p:cNvCxnSpPr>
              <a:cxnSpLocks/>
            </p:cNvCxnSpPr>
            <p:nvPr/>
          </p:nvCxnSpPr>
          <p:spPr>
            <a:xfrm>
              <a:off x="8475583" y="4869160"/>
              <a:ext cx="21602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Gerader Verbinder 114">
              <a:extLst>
                <a:ext uri="{FF2B5EF4-FFF2-40B4-BE49-F238E27FC236}">
                  <a16:creationId xmlns:a16="http://schemas.microsoft.com/office/drawing/2014/main" id="{32284026-F50B-4F53-B974-73FA5FB0CD83}"/>
                </a:ext>
              </a:extLst>
            </p:cNvPr>
            <p:cNvCxnSpPr>
              <a:cxnSpLocks/>
            </p:cNvCxnSpPr>
            <p:nvPr/>
          </p:nvCxnSpPr>
          <p:spPr>
            <a:xfrm>
              <a:off x="8475583" y="3284984"/>
              <a:ext cx="21602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Gerader Verbinder 114">
              <a:extLst>
                <a:ext uri="{FF2B5EF4-FFF2-40B4-BE49-F238E27FC236}">
                  <a16:creationId xmlns:a16="http://schemas.microsoft.com/office/drawing/2014/main" id="{66DD66C2-7ED3-4DE8-B73F-B1928BC8C9AB}"/>
                </a:ext>
              </a:extLst>
            </p:cNvPr>
            <p:cNvCxnSpPr>
              <a:cxnSpLocks/>
            </p:cNvCxnSpPr>
            <p:nvPr/>
          </p:nvCxnSpPr>
          <p:spPr>
            <a:xfrm>
              <a:off x="8475583" y="1700808"/>
              <a:ext cx="21602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27702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Breitbild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enblock, Charlotte</dc:creator>
  <cp:lastModifiedBy>Steenblock, Charlotte</cp:lastModifiedBy>
  <cp:revision>1</cp:revision>
  <dcterms:created xsi:type="dcterms:W3CDTF">2020-08-28T12:27:20Z</dcterms:created>
  <dcterms:modified xsi:type="dcterms:W3CDTF">2020-10-19T08:01:28Z</dcterms:modified>
</cp:coreProperties>
</file>